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sldIdLst>
    <p:sldId id="267" r:id="rId2"/>
    <p:sldId id="268" r:id="rId3"/>
    <p:sldId id="270" r:id="rId4"/>
    <p:sldId id="265" r:id="rId5"/>
    <p:sldId id="269" r:id="rId6"/>
    <p:sldId id="272" r:id="rId7"/>
    <p:sldId id="271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170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094BDEC-C156-4421-A96F-18D85D655B11}" type="datetimeFigureOut">
              <a:rPr lang="en-US" smtClean="0"/>
              <a:t>9/1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48FA1B-B625-4071-9003-DCD4376B79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99763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B6A1B-2A35-4B0A-A744-6A671BE6203B}" type="datetimeFigureOut">
              <a:rPr lang="en-US" smtClean="0"/>
              <a:t>9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D2A2C-F64D-4021-B2F5-F4C876BC4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56500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B6A1B-2A35-4B0A-A744-6A671BE6203B}" type="datetimeFigureOut">
              <a:rPr lang="en-US" smtClean="0"/>
              <a:t>9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D2A2C-F64D-4021-B2F5-F4C876BC4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37737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B6A1B-2A35-4B0A-A744-6A671BE6203B}" type="datetimeFigureOut">
              <a:rPr lang="en-US" smtClean="0"/>
              <a:t>9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D2A2C-F64D-4021-B2F5-F4C876BC4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7060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B6A1B-2A35-4B0A-A744-6A671BE6203B}" type="datetimeFigureOut">
              <a:rPr lang="en-US" smtClean="0"/>
              <a:t>9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D2A2C-F64D-4021-B2F5-F4C876BC4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115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B6A1B-2A35-4B0A-A744-6A671BE6203B}" type="datetimeFigureOut">
              <a:rPr lang="en-US" smtClean="0"/>
              <a:t>9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D2A2C-F64D-4021-B2F5-F4C876BC4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49063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B6A1B-2A35-4B0A-A744-6A671BE6203B}" type="datetimeFigureOut">
              <a:rPr lang="en-US" smtClean="0"/>
              <a:t>9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D2A2C-F64D-4021-B2F5-F4C876BC4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16497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B6A1B-2A35-4B0A-A744-6A671BE6203B}" type="datetimeFigureOut">
              <a:rPr lang="en-US" smtClean="0"/>
              <a:t>9/1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D2A2C-F64D-4021-B2F5-F4C876BC4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22553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B6A1B-2A35-4B0A-A744-6A671BE6203B}" type="datetimeFigureOut">
              <a:rPr lang="en-US" smtClean="0"/>
              <a:t>9/1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D2A2C-F64D-4021-B2F5-F4C876BC4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46291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B6A1B-2A35-4B0A-A744-6A671BE6203B}" type="datetimeFigureOut">
              <a:rPr lang="en-US" smtClean="0"/>
              <a:t>9/1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D2A2C-F64D-4021-B2F5-F4C876BC4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6636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B6A1B-2A35-4B0A-A744-6A671BE6203B}" type="datetimeFigureOut">
              <a:rPr lang="en-US" smtClean="0"/>
              <a:t>9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D2A2C-F64D-4021-B2F5-F4C876BC4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118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B6A1B-2A35-4B0A-A744-6A671BE6203B}" type="datetimeFigureOut">
              <a:rPr lang="en-US" smtClean="0"/>
              <a:t>9/1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1D2A2C-F64D-4021-B2F5-F4C876BC4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3807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3B6A1B-2A35-4B0A-A744-6A671BE6203B}" type="datetimeFigureOut">
              <a:rPr lang="en-US" smtClean="0"/>
              <a:t>9/1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1D2A2C-F64D-4021-B2F5-F4C876BC42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65825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7.bin"/><Relationship Id="rId3" Type="http://schemas.openxmlformats.org/officeDocument/2006/relationships/image" Target="../media/image4.emf"/><Relationship Id="rId7" Type="http://schemas.openxmlformats.org/officeDocument/2006/relationships/image" Target="../media/image6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6.bin"/><Relationship Id="rId11" Type="http://schemas.openxmlformats.org/officeDocument/2006/relationships/image" Target="../media/image8.emf"/><Relationship Id="rId5" Type="http://schemas.openxmlformats.org/officeDocument/2006/relationships/image" Target="../media/image5.emf"/><Relationship Id="rId10" Type="http://schemas.openxmlformats.org/officeDocument/2006/relationships/oleObject" Target="../embeddings/oleObject8.bin"/><Relationship Id="rId4" Type="http://schemas.openxmlformats.org/officeDocument/2006/relationships/oleObject" Target="../embeddings/oleObject5.bin"/><Relationship Id="rId9" Type="http://schemas.openxmlformats.org/officeDocument/2006/relationships/image" Target="../media/image7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1.bin"/><Relationship Id="rId13" Type="http://schemas.openxmlformats.org/officeDocument/2006/relationships/image" Target="../media/image16.png"/><Relationship Id="rId3" Type="http://schemas.openxmlformats.org/officeDocument/2006/relationships/image" Target="../media/image10.png"/><Relationship Id="rId7" Type="http://schemas.openxmlformats.org/officeDocument/2006/relationships/image" Target="../media/image12.emf"/><Relationship Id="rId12" Type="http://schemas.openxmlformats.org/officeDocument/2006/relationships/image" Target="../media/image15.TIF"/><Relationship Id="rId2" Type="http://schemas.openxmlformats.org/officeDocument/2006/relationships/image" Target="../media/image9.png"/><Relationship Id="rId16" Type="http://schemas.openxmlformats.org/officeDocument/2006/relationships/image" Target="../media/image17.emf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0.bin"/><Relationship Id="rId11" Type="http://schemas.openxmlformats.org/officeDocument/2006/relationships/image" Target="../media/image14.emf"/><Relationship Id="rId5" Type="http://schemas.openxmlformats.org/officeDocument/2006/relationships/image" Target="../media/image11.emf"/><Relationship Id="rId15" Type="http://schemas.openxmlformats.org/officeDocument/2006/relationships/oleObject" Target="../embeddings/oleObject13.bin"/><Relationship Id="rId10" Type="http://schemas.openxmlformats.org/officeDocument/2006/relationships/oleObject" Target="../embeddings/oleObject12.bin"/><Relationship Id="rId4" Type="http://schemas.openxmlformats.org/officeDocument/2006/relationships/oleObject" Target="../embeddings/oleObject9.bin"/><Relationship Id="rId9" Type="http://schemas.openxmlformats.org/officeDocument/2006/relationships/image" Target="../media/image13.emf"/><Relationship Id="rId14" Type="http://schemas.microsoft.com/office/2007/relationships/hdphoto" Target="../media/hdphoto1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7.bin"/><Relationship Id="rId3" Type="http://schemas.openxmlformats.org/officeDocument/2006/relationships/image" Target="../media/image18.emf"/><Relationship Id="rId7" Type="http://schemas.openxmlformats.org/officeDocument/2006/relationships/image" Target="../media/image20.emf"/><Relationship Id="rId2" Type="http://schemas.openxmlformats.org/officeDocument/2006/relationships/oleObject" Target="../embeddings/oleObject14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6.bin"/><Relationship Id="rId11" Type="http://schemas.openxmlformats.org/officeDocument/2006/relationships/image" Target="../media/image22.emf"/><Relationship Id="rId5" Type="http://schemas.openxmlformats.org/officeDocument/2006/relationships/image" Target="../media/image19.emf"/><Relationship Id="rId10" Type="http://schemas.openxmlformats.org/officeDocument/2006/relationships/oleObject" Target="../embeddings/oleObject18.bin"/><Relationship Id="rId4" Type="http://schemas.openxmlformats.org/officeDocument/2006/relationships/oleObject" Target="../embeddings/oleObject15.bin"/><Relationship Id="rId9" Type="http://schemas.openxmlformats.org/officeDocument/2006/relationships/image" Target="../media/image21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7" Type="http://schemas.openxmlformats.org/officeDocument/2006/relationships/image" Target="../media/image26.emf"/><Relationship Id="rId2" Type="http://schemas.openxmlformats.org/officeDocument/2006/relationships/oleObject" Target="../embeddings/oleObject19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0.bin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png"/><Relationship Id="rId13" Type="http://schemas.openxmlformats.org/officeDocument/2006/relationships/image" Target="../media/image32.emf"/><Relationship Id="rId3" Type="http://schemas.microsoft.com/office/2007/relationships/hdphoto" Target="../media/hdphoto2.wdp"/><Relationship Id="rId7" Type="http://schemas.microsoft.com/office/2007/relationships/hdphoto" Target="../media/hdphoto4.wdp"/><Relationship Id="rId12" Type="http://schemas.openxmlformats.org/officeDocument/2006/relationships/oleObject" Target="../embeddings/oleObject21.bin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11" Type="http://schemas.microsoft.com/office/2007/relationships/hdphoto" Target="../media/hdphoto6.wdp"/><Relationship Id="rId5" Type="http://schemas.microsoft.com/office/2007/relationships/hdphoto" Target="../media/hdphoto3.wdp"/><Relationship Id="rId10" Type="http://schemas.openxmlformats.org/officeDocument/2006/relationships/image" Target="../media/image31.png"/><Relationship Id="rId4" Type="http://schemas.openxmlformats.org/officeDocument/2006/relationships/image" Target="../media/image28.png"/><Relationship Id="rId9" Type="http://schemas.microsoft.com/office/2007/relationships/hdphoto" Target="../media/hdphoto5.wdp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emf"/><Relationship Id="rId2" Type="http://schemas.openxmlformats.org/officeDocument/2006/relationships/oleObject" Target="../embeddings/oleObject22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5.TIF"/><Relationship Id="rId4" Type="http://schemas.openxmlformats.org/officeDocument/2006/relationships/image" Target="../media/image34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36480" y="218364"/>
            <a:ext cx="1078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Figure S1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214651" y="1378408"/>
            <a:ext cx="338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962749" y="1381179"/>
            <a:ext cx="338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B</a:t>
            </a:r>
          </a:p>
        </p:txBody>
      </p:sp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8015845"/>
              </p:ext>
            </p:extLst>
          </p:nvPr>
        </p:nvGraphicFramePr>
        <p:xfrm>
          <a:off x="3143250" y="1646238"/>
          <a:ext cx="1665288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424073" imgH="2933455" progId="Prism9.Document">
                  <p:embed/>
                </p:oleObj>
              </mc:Choice>
              <mc:Fallback>
                <p:oleObj name="Prism 9" r:id="rId2" imgW="2424073" imgH="293345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143250" y="1646238"/>
                        <a:ext cx="1665288" cy="2016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71578391"/>
              </p:ext>
            </p:extLst>
          </p:nvPr>
        </p:nvGraphicFramePr>
        <p:xfrm>
          <a:off x="4916488" y="1624013"/>
          <a:ext cx="1798637" cy="20367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616026" imgH="2964068" progId="Prism9.Document">
                  <p:embed/>
                </p:oleObj>
              </mc:Choice>
              <mc:Fallback>
                <p:oleObj name="Prism 9" r:id="rId4" imgW="2616026" imgH="296406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916488" y="1624013"/>
                        <a:ext cx="1798637" cy="20367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/>
          <p:cNvSpPr txBox="1"/>
          <p:nvPr/>
        </p:nvSpPr>
        <p:spPr>
          <a:xfrm>
            <a:off x="4755300" y="1378408"/>
            <a:ext cx="338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C</a:t>
            </a:r>
          </a:p>
        </p:txBody>
      </p:sp>
      <p:graphicFrame>
        <p:nvGraphicFramePr>
          <p:cNvPr id="22" name="Object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9399552"/>
              </p:ext>
            </p:extLst>
          </p:nvPr>
        </p:nvGraphicFramePr>
        <p:xfrm>
          <a:off x="1477963" y="1633538"/>
          <a:ext cx="1562100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2273177" imgH="2933455" progId="Prism9.Document">
                  <p:embed/>
                </p:oleObj>
              </mc:Choice>
              <mc:Fallback>
                <p:oleObj name="Prism 9" r:id="rId6" imgW="2273177" imgH="293345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477963" y="1633538"/>
                        <a:ext cx="1562100" cy="2016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916981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36480" y="218364"/>
            <a:ext cx="10781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Figure S2</a:t>
            </a:r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27025870"/>
              </p:ext>
            </p:extLst>
          </p:nvPr>
        </p:nvGraphicFramePr>
        <p:xfrm>
          <a:off x="3508375" y="879475"/>
          <a:ext cx="1531938" cy="1730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230320" imgH="2521799" progId="Prism9.Document">
                  <p:embed/>
                </p:oleObj>
              </mc:Choice>
              <mc:Fallback>
                <p:oleObj name="Prism 9" r:id="rId2" imgW="2230320" imgH="252179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508375" y="879475"/>
                        <a:ext cx="1531938" cy="1730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91145774"/>
              </p:ext>
            </p:extLst>
          </p:nvPr>
        </p:nvGraphicFramePr>
        <p:xfrm>
          <a:off x="1376146" y="952190"/>
          <a:ext cx="2027238" cy="1854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4" imgW="2952000" imgH="2700000" progId="Prism5.Document">
                  <p:embed/>
                </p:oleObj>
              </mc:Choice>
              <mc:Fallback>
                <p:oleObj name="Prism Project" r:id="rId4" imgW="2952000" imgH="2700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376146" y="952190"/>
                        <a:ext cx="2027238" cy="1854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76883782"/>
              </p:ext>
            </p:extLst>
          </p:nvPr>
        </p:nvGraphicFramePr>
        <p:xfrm>
          <a:off x="5334000" y="879475"/>
          <a:ext cx="1512888" cy="1730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2202950" imgH="2521799" progId="Prism9.Document">
                  <p:embed/>
                </p:oleObj>
              </mc:Choice>
              <mc:Fallback>
                <p:oleObj name="Prism 9" r:id="rId6" imgW="2202950" imgH="252179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334000" y="879475"/>
                        <a:ext cx="1512888" cy="1730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29940594"/>
              </p:ext>
            </p:extLst>
          </p:nvPr>
        </p:nvGraphicFramePr>
        <p:xfrm>
          <a:off x="1376363" y="2805113"/>
          <a:ext cx="1509712" cy="17319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2198268" imgH="2521799" progId="Prism9.Document">
                  <p:embed/>
                </p:oleObj>
              </mc:Choice>
              <mc:Fallback>
                <p:oleObj name="Prism 9" r:id="rId8" imgW="2198268" imgH="2521799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376363" y="2805113"/>
                        <a:ext cx="1509712" cy="17319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8182428"/>
              </p:ext>
            </p:extLst>
          </p:nvPr>
        </p:nvGraphicFramePr>
        <p:xfrm>
          <a:off x="3422650" y="2805113"/>
          <a:ext cx="1582738" cy="17319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2303788" imgH="2524680" progId="Prism9.Document">
                  <p:embed/>
                </p:oleObj>
              </mc:Choice>
              <mc:Fallback>
                <p:oleObj name="Prism 9" r:id="rId10" imgW="2303788" imgH="252468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422650" y="2805113"/>
                        <a:ext cx="1582738" cy="17319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1291980" y="879165"/>
            <a:ext cx="338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326682" y="881936"/>
            <a:ext cx="338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B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197441" y="879165"/>
            <a:ext cx="338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C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291980" y="2731052"/>
            <a:ext cx="338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D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264506" y="2731052"/>
            <a:ext cx="338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28337343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29821" y="466298"/>
            <a:ext cx="11742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Figure S3</a:t>
            </a:r>
          </a:p>
        </p:txBody>
      </p:sp>
      <p:grpSp>
        <p:nvGrpSpPr>
          <p:cNvPr id="11" name="Group 10"/>
          <p:cNvGrpSpPr/>
          <p:nvPr/>
        </p:nvGrpSpPr>
        <p:grpSpPr>
          <a:xfrm>
            <a:off x="916925" y="1360016"/>
            <a:ext cx="3188774" cy="1371609"/>
            <a:chOff x="885515" y="839156"/>
            <a:chExt cx="3188774" cy="1371609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316"/>
            <a:stretch/>
          </p:blipFill>
          <p:spPr>
            <a:xfrm>
              <a:off x="2454504" y="1126770"/>
              <a:ext cx="1504618" cy="1083995"/>
            </a:xfrm>
            <a:prstGeom prst="rect">
              <a:avLst/>
            </a:prstGeom>
          </p:spPr>
        </p:pic>
        <p:pic>
          <p:nvPicPr>
            <p:cNvPr id="8" name="Picture 7"/>
            <p:cNvPicPr preferRelativeResize="0"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338"/>
            <a:stretch/>
          </p:blipFill>
          <p:spPr>
            <a:xfrm>
              <a:off x="885515" y="1126771"/>
              <a:ext cx="1504618" cy="1083600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1411074" y="839156"/>
              <a:ext cx="7643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HK" sz="1400" dirty="0"/>
                <a:t>Ctrl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418493" y="841409"/>
              <a:ext cx="16557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HK" sz="1400" dirty="0"/>
                <a:t>Fat transplantation</a:t>
              </a:r>
            </a:p>
          </p:txBody>
        </p:sp>
      </p:grpSp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14525770"/>
              </p:ext>
            </p:extLst>
          </p:nvPr>
        </p:nvGraphicFramePr>
        <p:xfrm>
          <a:off x="4291013" y="1257300"/>
          <a:ext cx="1503362" cy="1724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364651" imgH="2723125" progId="Prism9.Document">
                  <p:embed/>
                </p:oleObj>
              </mc:Choice>
              <mc:Fallback>
                <p:oleObj name="Prism 9" r:id="rId4" imgW="2364651" imgH="272312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291013" y="1257300"/>
                        <a:ext cx="1503362" cy="1724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60498495"/>
              </p:ext>
            </p:extLst>
          </p:nvPr>
        </p:nvGraphicFramePr>
        <p:xfrm>
          <a:off x="5899150" y="1257300"/>
          <a:ext cx="1503363" cy="1724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2364651" imgH="2723125" progId="Prism9.Document">
                  <p:embed/>
                </p:oleObj>
              </mc:Choice>
              <mc:Fallback>
                <p:oleObj name="Prism 9" r:id="rId6" imgW="2364651" imgH="272312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899150" y="1257300"/>
                        <a:ext cx="1503363" cy="1724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578321" y="1120991"/>
            <a:ext cx="338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A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217925" y="1123762"/>
            <a:ext cx="338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B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5810885" y="1120991"/>
            <a:ext cx="338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E14A638-D089-4337-9111-2EE81061062A}"/>
              </a:ext>
            </a:extLst>
          </p:cNvPr>
          <p:cNvSpPr txBox="1"/>
          <p:nvPr/>
        </p:nvSpPr>
        <p:spPr>
          <a:xfrm>
            <a:off x="578321" y="3173900"/>
            <a:ext cx="338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D</a:t>
            </a:r>
          </a:p>
        </p:txBody>
      </p:sp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2811A346-D33D-4CDC-B516-A4B9438C112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13129235"/>
              </p:ext>
            </p:extLst>
          </p:nvPr>
        </p:nvGraphicFramePr>
        <p:xfrm>
          <a:off x="754063" y="3335338"/>
          <a:ext cx="1500187" cy="1755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2359969" imgH="2771745" progId="Prism9.Document">
                  <p:embed/>
                </p:oleObj>
              </mc:Choice>
              <mc:Fallback>
                <p:oleObj name="Prism 9" r:id="rId8" imgW="2359969" imgH="2771745" progId="Prism9.Document">
                  <p:embed/>
                  <p:pic>
                    <p:nvPicPr>
                      <p:cNvPr id="12" name="Object 11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754063" y="3335338"/>
                        <a:ext cx="1500187" cy="1755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A8D8341B-D8A6-4921-9BD9-A57908A66DA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30942574"/>
              </p:ext>
            </p:extLst>
          </p:nvPr>
        </p:nvGraphicFramePr>
        <p:xfrm>
          <a:off x="2121423" y="3335338"/>
          <a:ext cx="1500187" cy="1755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2359969" imgH="2771745" progId="Prism9.Document">
                  <p:embed/>
                </p:oleObj>
              </mc:Choice>
              <mc:Fallback>
                <p:oleObj name="Prism 9" r:id="rId10" imgW="2359969" imgH="2771745" progId="Prism9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2811A346-D33D-4CDC-B516-A4B9438C112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121423" y="3335338"/>
                        <a:ext cx="1500187" cy="1755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9" name="Group 18">
            <a:extLst>
              <a:ext uri="{FF2B5EF4-FFF2-40B4-BE49-F238E27FC236}">
                <a16:creationId xmlns:a16="http://schemas.microsoft.com/office/drawing/2014/main" id="{4F106308-6D6E-4CC6-9D4E-DC8B155F5731}"/>
              </a:ext>
            </a:extLst>
          </p:cNvPr>
          <p:cNvGrpSpPr/>
          <p:nvPr/>
        </p:nvGrpSpPr>
        <p:grpSpPr>
          <a:xfrm>
            <a:off x="5119668" y="3543232"/>
            <a:ext cx="2944383" cy="1196454"/>
            <a:chOff x="3962065" y="3403407"/>
            <a:chExt cx="2944383" cy="1196454"/>
          </a:xfrm>
        </p:grpSpPr>
        <p:pic>
          <p:nvPicPr>
            <p:cNvPr id="3" name="Picture 2" descr="Close-up of a pen&#10;&#10;Description automatically generated with medium confidence">
              <a:extLst>
                <a:ext uri="{FF2B5EF4-FFF2-40B4-BE49-F238E27FC236}">
                  <a16:creationId xmlns:a16="http://schemas.microsoft.com/office/drawing/2014/main" id="{DA0ABC38-7295-483E-A1D4-11B711F687F3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606" t="48459" r="10518" b="33779"/>
            <a:stretch/>
          </p:blipFill>
          <p:spPr>
            <a:xfrm>
              <a:off x="4689413" y="4239861"/>
              <a:ext cx="21600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" name="Picture 5" descr="A picture containing indoor, close, blurry, blur&#10;&#10;Description automatically generated">
              <a:extLst>
                <a:ext uri="{FF2B5EF4-FFF2-40B4-BE49-F238E27FC236}">
                  <a16:creationId xmlns:a16="http://schemas.microsoft.com/office/drawing/2014/main" id="{2EE88026-0594-48B8-904F-6364275E8D9A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40" t="28375" r="10743" b="43927"/>
            <a:stretch/>
          </p:blipFill>
          <p:spPr>
            <a:xfrm>
              <a:off x="4689413" y="3823728"/>
              <a:ext cx="21600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9664F91-16E3-4317-B81D-96887BCD68F7}"/>
                </a:ext>
              </a:extLst>
            </p:cNvPr>
            <p:cNvSpPr txBox="1"/>
            <p:nvPr/>
          </p:nvSpPr>
          <p:spPr>
            <a:xfrm>
              <a:off x="4005029" y="3881566"/>
              <a:ext cx="7643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HK" sz="1400" dirty="0" err="1"/>
                <a:t>Vaspin</a:t>
              </a:r>
              <a:endParaRPr lang="en-HK" sz="1400" dirty="0"/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59A78B06-2BB9-4D15-9DEE-F4B417F2DE2D}"/>
                </a:ext>
              </a:extLst>
            </p:cNvPr>
            <p:cNvSpPr txBox="1"/>
            <p:nvPr/>
          </p:nvSpPr>
          <p:spPr>
            <a:xfrm>
              <a:off x="3990532" y="4265972"/>
              <a:ext cx="7643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HK" sz="1400" dirty="0"/>
                <a:t>Tubulin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754BB43-5337-497B-98BF-CCA7B51BE02E}"/>
                </a:ext>
              </a:extLst>
            </p:cNvPr>
            <p:cNvSpPr txBox="1"/>
            <p:nvPr/>
          </p:nvSpPr>
          <p:spPr>
            <a:xfrm>
              <a:off x="3962065" y="3523271"/>
              <a:ext cx="79069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HK" sz="1400" dirty="0" err="1"/>
                <a:t>si</a:t>
              </a:r>
              <a:r>
                <a:rPr lang="en-HK" sz="1400" i="1" dirty="0" err="1"/>
                <a:t>Vaspin</a:t>
              </a:r>
              <a:endParaRPr lang="en-HK" sz="1400" i="1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B276A515-D58F-4A53-9EEA-30EE24D8BFB4}"/>
                </a:ext>
              </a:extLst>
            </p:cNvPr>
            <p:cNvSpPr txBox="1"/>
            <p:nvPr/>
          </p:nvSpPr>
          <p:spPr>
            <a:xfrm>
              <a:off x="4726129" y="3404762"/>
              <a:ext cx="433727" cy="356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HK" sz="2000" dirty="0"/>
                <a:t>_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9FC61510-B96D-4F0F-A1DD-CFBE435D24C0}"/>
                </a:ext>
              </a:extLst>
            </p:cNvPr>
            <p:cNvSpPr txBox="1"/>
            <p:nvPr/>
          </p:nvSpPr>
          <p:spPr>
            <a:xfrm>
              <a:off x="5429911" y="3412476"/>
              <a:ext cx="433727" cy="356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HK" sz="2000" dirty="0"/>
                <a:t>_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74473274-14F8-463E-A9F3-760630E10E7E}"/>
                </a:ext>
              </a:extLst>
            </p:cNvPr>
            <p:cNvSpPr txBox="1"/>
            <p:nvPr/>
          </p:nvSpPr>
          <p:spPr>
            <a:xfrm>
              <a:off x="6140611" y="3403407"/>
              <a:ext cx="433727" cy="356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HK" sz="2000" dirty="0"/>
                <a:t>_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C8269CD-C9DC-41DC-9341-F31A9F4B7526}"/>
                </a:ext>
              </a:extLst>
            </p:cNvPr>
            <p:cNvSpPr txBox="1"/>
            <p:nvPr/>
          </p:nvSpPr>
          <p:spPr>
            <a:xfrm>
              <a:off x="5121709" y="3546688"/>
              <a:ext cx="4337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HK" sz="1400" dirty="0"/>
                <a:t>#1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2505E4C8-C8E3-4C8E-81B1-9E672B3FDB92}"/>
                </a:ext>
              </a:extLst>
            </p:cNvPr>
            <p:cNvSpPr txBox="1"/>
            <p:nvPr/>
          </p:nvSpPr>
          <p:spPr>
            <a:xfrm>
              <a:off x="5806093" y="3546688"/>
              <a:ext cx="4337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HK" sz="1400" dirty="0"/>
                <a:t>#2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22518BA5-357D-4A84-B59B-FD38B255F263}"/>
                </a:ext>
              </a:extLst>
            </p:cNvPr>
            <p:cNvSpPr txBox="1"/>
            <p:nvPr/>
          </p:nvSpPr>
          <p:spPr>
            <a:xfrm>
              <a:off x="6472721" y="3548492"/>
              <a:ext cx="4337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HK" sz="1400" dirty="0"/>
                <a:t>#3</a:t>
              </a:r>
            </a:p>
          </p:txBody>
        </p:sp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id="{60C9E293-11DF-4BF5-A5C3-742FB1221DD7}"/>
              </a:ext>
            </a:extLst>
          </p:cNvPr>
          <p:cNvSpPr txBox="1"/>
          <p:nvPr/>
        </p:nvSpPr>
        <p:spPr>
          <a:xfrm>
            <a:off x="3300961" y="3173900"/>
            <a:ext cx="338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E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E2A1511-0A52-415D-A73C-8B26B00AEF90}"/>
              </a:ext>
            </a:extLst>
          </p:cNvPr>
          <p:cNvSpPr txBox="1"/>
          <p:nvPr/>
        </p:nvSpPr>
        <p:spPr>
          <a:xfrm>
            <a:off x="5010290" y="3176536"/>
            <a:ext cx="338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F</a:t>
            </a:r>
          </a:p>
        </p:txBody>
      </p:sp>
      <p:graphicFrame>
        <p:nvGraphicFramePr>
          <p:cNvPr id="33" name="Object 32">
            <a:extLst>
              <a:ext uri="{FF2B5EF4-FFF2-40B4-BE49-F238E27FC236}">
                <a16:creationId xmlns:a16="http://schemas.microsoft.com/office/drawing/2014/main" id="{659A9CBC-20CD-4FD1-AC62-C7A6FF1B917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81758548"/>
              </p:ext>
            </p:extLst>
          </p:nvPr>
        </p:nvGraphicFramePr>
        <p:xfrm>
          <a:off x="3724275" y="3446463"/>
          <a:ext cx="1350963" cy="1603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5" imgW="2126962" imgH="2530802" progId="Prism9.Document">
                  <p:embed/>
                </p:oleObj>
              </mc:Choice>
              <mc:Fallback>
                <p:oleObj name="Prism 9" r:id="rId15" imgW="2126962" imgH="2530802" progId="Prism9.Document">
                  <p:embed/>
                  <p:pic>
                    <p:nvPicPr>
                      <p:cNvPr id="20" name="Object 19">
                        <a:extLst>
                          <a:ext uri="{FF2B5EF4-FFF2-40B4-BE49-F238E27FC236}">
                            <a16:creationId xmlns:a16="http://schemas.microsoft.com/office/drawing/2014/main" id="{A8D8341B-D8A6-4921-9BD9-A57908A66DA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724275" y="3446463"/>
                        <a:ext cx="1350963" cy="1603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253464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29821" y="466298"/>
            <a:ext cx="11742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Figure S4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043221" y="1244531"/>
            <a:ext cx="338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963080" y="1244531"/>
            <a:ext cx="338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B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882939" y="1292194"/>
            <a:ext cx="338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C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062390" y="3342367"/>
            <a:ext cx="338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D</a:t>
            </a:r>
          </a:p>
        </p:txBody>
      </p:sp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95261906"/>
              </p:ext>
            </p:extLst>
          </p:nvPr>
        </p:nvGraphicFramePr>
        <p:xfrm>
          <a:off x="4948238" y="1460500"/>
          <a:ext cx="1825625" cy="1887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657441" imgH="2750496" progId="Prism9.Document">
                  <p:embed/>
                </p:oleObj>
              </mc:Choice>
              <mc:Fallback>
                <p:oleObj name="Prism 9" r:id="rId2" imgW="2657441" imgH="275049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948238" y="1460500"/>
                        <a:ext cx="1825625" cy="18875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08088325"/>
              </p:ext>
            </p:extLst>
          </p:nvPr>
        </p:nvGraphicFramePr>
        <p:xfrm>
          <a:off x="1149350" y="3462338"/>
          <a:ext cx="1825625" cy="18875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657441" imgH="2750496" progId="Prism9.Document">
                  <p:embed/>
                </p:oleObj>
              </mc:Choice>
              <mc:Fallback>
                <p:oleObj name="Prism 9" r:id="rId4" imgW="2657441" imgH="275049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149350" y="3462338"/>
                        <a:ext cx="1825625" cy="18875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Box 18"/>
          <p:cNvSpPr txBox="1"/>
          <p:nvPr/>
        </p:nvSpPr>
        <p:spPr>
          <a:xfrm>
            <a:off x="2945014" y="3342367"/>
            <a:ext cx="338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E</a:t>
            </a:r>
          </a:p>
        </p:txBody>
      </p:sp>
      <p:graphicFrame>
        <p:nvGraphicFramePr>
          <p:cNvPr id="20" name="Object 1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89261387"/>
              </p:ext>
            </p:extLst>
          </p:nvPr>
        </p:nvGraphicFramePr>
        <p:xfrm>
          <a:off x="3133725" y="3462338"/>
          <a:ext cx="1895475" cy="18875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2762601" imgH="2750496" progId="Prism9.Document">
                  <p:embed/>
                </p:oleObj>
              </mc:Choice>
              <mc:Fallback>
                <p:oleObj name="Prism 9" r:id="rId6" imgW="2762601" imgH="275049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133725" y="3462338"/>
                        <a:ext cx="1895475" cy="18875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39570857"/>
              </p:ext>
            </p:extLst>
          </p:nvPr>
        </p:nvGraphicFramePr>
        <p:xfrm>
          <a:off x="1152525" y="1473200"/>
          <a:ext cx="1760538" cy="1887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2561285" imgH="2750496" progId="Prism9.Document">
                  <p:embed/>
                </p:oleObj>
              </mc:Choice>
              <mc:Fallback>
                <p:oleObj name="Prism 9" r:id="rId8" imgW="2561285" imgH="2750496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152525" y="1473200"/>
                        <a:ext cx="1760538" cy="18875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88671326"/>
              </p:ext>
            </p:extLst>
          </p:nvPr>
        </p:nvGraphicFramePr>
        <p:xfrm>
          <a:off x="3014663" y="1449388"/>
          <a:ext cx="1897062" cy="1933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2762601" imgH="2817485" progId="Prism9.Document">
                  <p:embed/>
                </p:oleObj>
              </mc:Choice>
              <mc:Fallback>
                <p:oleObj name="Prism 9" r:id="rId10" imgW="2762601" imgH="281748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014663" y="1449388"/>
                        <a:ext cx="1897062" cy="1933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9960807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29821" y="466298"/>
            <a:ext cx="11742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Figure S5</a:t>
            </a:r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50623371"/>
              </p:ext>
            </p:extLst>
          </p:nvPr>
        </p:nvGraphicFramePr>
        <p:xfrm>
          <a:off x="4817292" y="1135556"/>
          <a:ext cx="1597025" cy="20145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323596" imgH="2933455" progId="Prism9.Document">
                  <p:embed/>
                </p:oleObj>
              </mc:Choice>
              <mc:Fallback>
                <p:oleObj name="Prism 9" r:id="rId2" imgW="2323596" imgH="2933455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817292" y="1135556"/>
                        <a:ext cx="1597025" cy="20145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" name="Picture 1"/>
          <p:cNvPicPr preferRelativeResize="0"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1684" y="2374128"/>
            <a:ext cx="2880000" cy="36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" name="Picture 2"/>
          <p:cNvPicPr preferRelativeResize="0"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1684" y="1926130"/>
            <a:ext cx="2880000" cy="36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9" name="TextBox 8"/>
          <p:cNvSpPr txBox="1"/>
          <p:nvPr/>
        </p:nvSpPr>
        <p:spPr>
          <a:xfrm>
            <a:off x="924312" y="1987745"/>
            <a:ext cx="7643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sz="1400" dirty="0"/>
              <a:t>p-AKT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014579" y="2426351"/>
            <a:ext cx="7643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sz="1400" dirty="0"/>
              <a:t>AKT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746763" y="1610994"/>
            <a:ext cx="5609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sz="1400" dirty="0"/>
              <a:t>C57</a:t>
            </a:r>
          </a:p>
        </p:txBody>
      </p:sp>
      <p:sp>
        <p:nvSpPr>
          <p:cNvPr id="12" name="Rectangle 11"/>
          <p:cNvSpPr/>
          <p:nvPr/>
        </p:nvSpPr>
        <p:spPr>
          <a:xfrm>
            <a:off x="2491114" y="1321155"/>
            <a:ext cx="202978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A-ZIP/F-1 mouse (weeks) </a:t>
            </a:r>
            <a:endParaRPr lang="en-US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2477439" y="1610993"/>
            <a:ext cx="5609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sz="1400" dirty="0"/>
              <a:t>4</a:t>
            </a:r>
          </a:p>
        </p:txBody>
      </p:sp>
      <p:cxnSp>
        <p:nvCxnSpPr>
          <p:cNvPr id="16" name="Straight Connector 15"/>
          <p:cNvCxnSpPr/>
          <p:nvPr/>
        </p:nvCxnSpPr>
        <p:spPr>
          <a:xfrm>
            <a:off x="2423285" y="1659968"/>
            <a:ext cx="186116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1759982" y="1871538"/>
            <a:ext cx="42535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/>
          <p:cNvCxnSpPr/>
          <p:nvPr/>
        </p:nvCxnSpPr>
        <p:spPr>
          <a:xfrm>
            <a:off x="2403878" y="1871538"/>
            <a:ext cx="42535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3227015" y="1617849"/>
            <a:ext cx="5609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sz="1400" dirty="0"/>
              <a:t>12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3916747" y="1617848"/>
            <a:ext cx="5609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sz="1400" dirty="0"/>
              <a:t>24</a:t>
            </a:r>
          </a:p>
        </p:txBody>
      </p:sp>
      <p:cxnSp>
        <p:nvCxnSpPr>
          <p:cNvPr id="23" name="Straight Connector 22"/>
          <p:cNvCxnSpPr/>
          <p:nvPr/>
        </p:nvCxnSpPr>
        <p:spPr>
          <a:xfrm>
            <a:off x="3199290" y="1878393"/>
            <a:ext cx="42535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3843186" y="1878393"/>
            <a:ext cx="42535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667987" y="1138708"/>
            <a:ext cx="338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A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4493392" y="1136489"/>
            <a:ext cx="338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B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77804C4-B9FE-4159-9D03-E273B7604299}"/>
              </a:ext>
            </a:extLst>
          </p:cNvPr>
          <p:cNvSpPr txBox="1"/>
          <p:nvPr/>
        </p:nvSpPr>
        <p:spPr>
          <a:xfrm>
            <a:off x="667987" y="3168362"/>
            <a:ext cx="338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C</a:t>
            </a:r>
          </a:p>
        </p:txBody>
      </p:sp>
      <p:graphicFrame>
        <p:nvGraphicFramePr>
          <p:cNvPr id="26" name="Object 25">
            <a:extLst>
              <a:ext uri="{FF2B5EF4-FFF2-40B4-BE49-F238E27FC236}">
                <a16:creationId xmlns:a16="http://schemas.microsoft.com/office/drawing/2014/main" id="{F06148A4-977D-4DA0-885D-47F1AE38271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57036142"/>
              </p:ext>
            </p:extLst>
          </p:nvPr>
        </p:nvGraphicFramePr>
        <p:xfrm>
          <a:off x="1172392" y="3237406"/>
          <a:ext cx="1395412" cy="17383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2030805" imgH="2530802" progId="Prism9.Document">
                  <p:embed/>
                </p:oleObj>
              </mc:Choice>
              <mc:Fallback>
                <p:oleObj name="Prism 9" r:id="rId6" imgW="2030805" imgH="2530802" progId="Prism9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172392" y="3237406"/>
                        <a:ext cx="1395412" cy="17383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316570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CC78784-506A-425C-8A38-9A5E8C307E64}"/>
              </a:ext>
            </a:extLst>
          </p:cNvPr>
          <p:cNvSpPr txBox="1"/>
          <p:nvPr/>
        </p:nvSpPr>
        <p:spPr>
          <a:xfrm>
            <a:off x="329821" y="466298"/>
            <a:ext cx="11742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Figure S6</a:t>
            </a:r>
          </a:p>
        </p:txBody>
      </p:sp>
      <p:pic>
        <p:nvPicPr>
          <p:cNvPr id="6" name="Picture 5" descr="Background pattern&#10;&#10;Description automatically generated with medium confidence">
            <a:extLst>
              <a:ext uri="{FF2B5EF4-FFF2-40B4-BE49-F238E27FC236}">
                <a16:creationId xmlns:a16="http://schemas.microsoft.com/office/drawing/2014/main" id="{B63C1E49-0678-4FEE-B224-B9F620BEAE7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886" t="33835" r="15476" b="27535"/>
          <a:stretch/>
        </p:blipFill>
        <p:spPr>
          <a:xfrm>
            <a:off x="1609382" y="1713390"/>
            <a:ext cx="1800000" cy="36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8" name="Picture 7" descr="A group of black dots&#10;&#10;Description automatically generated with low confidence">
            <a:extLst>
              <a:ext uri="{FF2B5EF4-FFF2-40B4-BE49-F238E27FC236}">
                <a16:creationId xmlns:a16="http://schemas.microsoft.com/office/drawing/2014/main" id="{3398E07B-3FC6-4CF4-8427-AB3D72E5CC7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069" t="45723" r="9916"/>
          <a:stretch/>
        </p:blipFill>
        <p:spPr>
          <a:xfrm>
            <a:off x="1609382" y="2577647"/>
            <a:ext cx="1800000" cy="36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59C58672-EF67-4E07-8D60-1A547F2C05CD}"/>
              </a:ext>
            </a:extLst>
          </p:cNvPr>
          <p:cNvSpPr txBox="1"/>
          <p:nvPr/>
        </p:nvSpPr>
        <p:spPr>
          <a:xfrm>
            <a:off x="1000356" y="1751235"/>
            <a:ext cx="5735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/>
              <a:t>p</a:t>
            </a:r>
            <a:r>
              <a:rPr lang="en-HK" sz="1400" dirty="0"/>
              <a:t>AK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27846EF-D63F-45DA-87B6-8C5DD494DCD1}"/>
              </a:ext>
            </a:extLst>
          </p:cNvPr>
          <p:cNvSpPr txBox="1"/>
          <p:nvPr/>
        </p:nvSpPr>
        <p:spPr>
          <a:xfrm>
            <a:off x="1000356" y="2177961"/>
            <a:ext cx="5735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altLang="zh-CN" sz="1400" dirty="0"/>
              <a:t>AKT</a:t>
            </a:r>
            <a:endParaRPr lang="en-HK" sz="14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F15433C-5E2D-45CD-80AA-05ED685736B0}"/>
              </a:ext>
            </a:extLst>
          </p:cNvPr>
          <p:cNvSpPr txBox="1"/>
          <p:nvPr/>
        </p:nvSpPr>
        <p:spPr>
          <a:xfrm>
            <a:off x="782582" y="1275937"/>
            <a:ext cx="101810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sz="1400" dirty="0"/>
              <a:t>    V</a:t>
            </a:r>
            <a:r>
              <a:rPr lang="en-US" altLang="zh-CN" sz="1400" dirty="0" err="1"/>
              <a:t>aspin</a:t>
            </a:r>
            <a:endParaRPr lang="en-US" altLang="zh-CN" sz="1400" dirty="0"/>
          </a:p>
          <a:p>
            <a:pPr algn="just"/>
            <a:r>
              <a:rPr lang="zh-CN" altLang="en-US" sz="1400" dirty="0"/>
              <a:t>（</a:t>
            </a:r>
            <a:r>
              <a:rPr lang="en-US" altLang="zh-CN" sz="1400" dirty="0"/>
              <a:t>µg/ml</a:t>
            </a:r>
            <a:r>
              <a:rPr lang="zh-CN" altLang="en-US" sz="1400" dirty="0"/>
              <a:t>）</a:t>
            </a:r>
            <a:endParaRPr lang="en-HK" sz="14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AB6AC59-5320-4CFA-9B3D-FA6256CD7DF2}"/>
              </a:ext>
            </a:extLst>
          </p:cNvPr>
          <p:cNvSpPr txBox="1"/>
          <p:nvPr/>
        </p:nvSpPr>
        <p:spPr>
          <a:xfrm>
            <a:off x="1607192" y="1233361"/>
            <a:ext cx="433727" cy="356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sz="2000" dirty="0"/>
              <a:t>_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AE4EC79-D92D-4989-8352-439BA39DCD08}"/>
              </a:ext>
            </a:extLst>
          </p:cNvPr>
          <p:cNvSpPr txBox="1"/>
          <p:nvPr/>
        </p:nvSpPr>
        <p:spPr>
          <a:xfrm>
            <a:off x="1989308" y="1387678"/>
            <a:ext cx="5284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sz="1400" dirty="0"/>
              <a:t>0.05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0F7EC0C-1CC2-481E-A467-B12C6168D2A9}"/>
              </a:ext>
            </a:extLst>
          </p:cNvPr>
          <p:cNvSpPr txBox="1"/>
          <p:nvPr/>
        </p:nvSpPr>
        <p:spPr>
          <a:xfrm>
            <a:off x="2487967" y="1390378"/>
            <a:ext cx="5284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sz="1400" dirty="0"/>
              <a:t>0.25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FF2BA17-BEA9-45A6-8C26-EFB17A27F903}"/>
              </a:ext>
            </a:extLst>
          </p:cNvPr>
          <p:cNvSpPr txBox="1"/>
          <p:nvPr/>
        </p:nvSpPr>
        <p:spPr>
          <a:xfrm>
            <a:off x="2941879" y="1381660"/>
            <a:ext cx="5284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sz="1400" dirty="0"/>
              <a:t>2.5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636F24E-EA04-41EF-B39F-E6FF5BF85724}"/>
              </a:ext>
            </a:extLst>
          </p:cNvPr>
          <p:cNvSpPr txBox="1"/>
          <p:nvPr/>
        </p:nvSpPr>
        <p:spPr>
          <a:xfrm>
            <a:off x="867213" y="3464442"/>
            <a:ext cx="7643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sz="1400" dirty="0"/>
              <a:t>Tubulin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1185284-9674-4DAE-BBCD-BD6422E945E1}"/>
              </a:ext>
            </a:extLst>
          </p:cNvPr>
          <p:cNvSpPr txBox="1"/>
          <p:nvPr/>
        </p:nvSpPr>
        <p:spPr>
          <a:xfrm>
            <a:off x="867212" y="2587727"/>
            <a:ext cx="7643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400" dirty="0"/>
              <a:t>p</a:t>
            </a:r>
            <a:r>
              <a:rPr lang="en-HK" sz="1400" dirty="0"/>
              <a:t>GSK3</a:t>
            </a:r>
            <a:r>
              <a:rPr lang="el-GR" sz="1400" dirty="0"/>
              <a:t>β</a:t>
            </a:r>
            <a:endParaRPr lang="en-HK" sz="1400" dirty="0"/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0FB4E4E3-F703-4377-A943-318D7CD558E9}"/>
              </a:ext>
            </a:extLst>
          </p:cNvPr>
          <p:cNvPicPr preferRelativeResize="0">
            <a:picLocks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1607192" y="3443471"/>
            <a:ext cx="1800000" cy="36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5272DECA-C5ED-4D68-99E1-D6A7A3864604}"/>
              </a:ext>
            </a:extLst>
          </p:cNvPr>
          <p:cNvSpPr txBox="1"/>
          <p:nvPr/>
        </p:nvSpPr>
        <p:spPr>
          <a:xfrm>
            <a:off x="878308" y="3049118"/>
            <a:ext cx="7643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sz="1400" dirty="0"/>
              <a:t>GSK3</a:t>
            </a:r>
            <a:r>
              <a:rPr lang="el-GR" sz="1400" dirty="0"/>
              <a:t>β</a:t>
            </a:r>
            <a:endParaRPr lang="en-HK" sz="14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6220E6A-1AC0-4EBE-AD01-A33A9F82F278}"/>
              </a:ext>
            </a:extLst>
          </p:cNvPr>
          <p:cNvPicPr preferRelativeResize="0">
            <a:picLocks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7732" y="2140296"/>
            <a:ext cx="1800000" cy="36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E034B552-4513-42D3-943B-21A765C595BB}"/>
              </a:ext>
            </a:extLst>
          </p:cNvPr>
          <p:cNvPicPr preferRelativeResize="0">
            <a:picLocks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7191" y="3011942"/>
            <a:ext cx="1800000" cy="36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DBD3ABE5-1EA2-44F6-A34E-5D12C7FD4F34}"/>
              </a:ext>
            </a:extLst>
          </p:cNvPr>
          <p:cNvSpPr txBox="1"/>
          <p:nvPr/>
        </p:nvSpPr>
        <p:spPr>
          <a:xfrm>
            <a:off x="709006" y="935433"/>
            <a:ext cx="338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E370481-FBBA-4AD8-8788-3D334A571CA4}"/>
              </a:ext>
            </a:extLst>
          </p:cNvPr>
          <p:cNvSpPr txBox="1"/>
          <p:nvPr/>
        </p:nvSpPr>
        <p:spPr>
          <a:xfrm>
            <a:off x="3470304" y="969265"/>
            <a:ext cx="338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B</a:t>
            </a:r>
          </a:p>
        </p:txBody>
      </p:sp>
      <p:graphicFrame>
        <p:nvGraphicFramePr>
          <p:cNvPr id="31" name="Object 30">
            <a:extLst>
              <a:ext uri="{FF2B5EF4-FFF2-40B4-BE49-F238E27FC236}">
                <a16:creationId xmlns:a16="http://schemas.microsoft.com/office/drawing/2014/main" id="{8353032D-5444-4BD0-9C65-68F33A13CBE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7409406"/>
              </p:ext>
            </p:extLst>
          </p:nvPr>
        </p:nvGraphicFramePr>
        <p:xfrm>
          <a:off x="3762375" y="1530350"/>
          <a:ext cx="3944938" cy="23637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4280933" imgH="2566098" progId="Prism9.Document">
                  <p:embed/>
                </p:oleObj>
              </mc:Choice>
              <mc:Fallback>
                <p:oleObj name="Prism 9" r:id="rId12" imgW="4280933" imgH="2566098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762375" y="1530350"/>
                        <a:ext cx="3944938" cy="23637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99754832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9C76BF3-B56F-48FB-8334-8F54BC0B7B2B}"/>
              </a:ext>
            </a:extLst>
          </p:cNvPr>
          <p:cNvSpPr txBox="1"/>
          <p:nvPr/>
        </p:nvSpPr>
        <p:spPr>
          <a:xfrm>
            <a:off x="329821" y="466298"/>
            <a:ext cx="11742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Figure S7</a:t>
            </a:r>
          </a:p>
        </p:txBody>
      </p:sp>
      <p:graphicFrame>
        <p:nvGraphicFramePr>
          <p:cNvPr id="20" name="Object 19">
            <a:extLst>
              <a:ext uri="{FF2B5EF4-FFF2-40B4-BE49-F238E27FC236}">
                <a16:creationId xmlns:a16="http://schemas.microsoft.com/office/drawing/2014/main" id="{85C6723B-9776-44EF-B097-85279D50959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08412422"/>
              </p:ext>
            </p:extLst>
          </p:nvPr>
        </p:nvGraphicFramePr>
        <p:xfrm>
          <a:off x="3354388" y="969963"/>
          <a:ext cx="2436812" cy="1749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549137" imgH="2547730" progId="Prism9.Document">
                  <p:embed/>
                </p:oleObj>
              </mc:Choice>
              <mc:Fallback>
                <p:oleObj name="Prism 9" r:id="rId2" imgW="3549137" imgH="2547730" progId="Prism9.Document">
                  <p:embed/>
                  <p:pic>
                    <p:nvPicPr>
                      <p:cNvPr id="19" name="Object 18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354388" y="969963"/>
                        <a:ext cx="2436812" cy="1749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TextBox 20">
            <a:extLst>
              <a:ext uri="{FF2B5EF4-FFF2-40B4-BE49-F238E27FC236}">
                <a16:creationId xmlns:a16="http://schemas.microsoft.com/office/drawing/2014/main" id="{3095CB8C-0920-4AEA-BBAC-5CAB45D4DA84}"/>
              </a:ext>
            </a:extLst>
          </p:cNvPr>
          <p:cNvSpPr txBox="1"/>
          <p:nvPr/>
        </p:nvSpPr>
        <p:spPr>
          <a:xfrm>
            <a:off x="721372" y="882714"/>
            <a:ext cx="338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4413727-E37E-49E3-962D-3512EC1AE7D2}"/>
              </a:ext>
            </a:extLst>
          </p:cNvPr>
          <p:cNvSpPr txBox="1"/>
          <p:nvPr/>
        </p:nvSpPr>
        <p:spPr>
          <a:xfrm>
            <a:off x="3146235" y="883736"/>
            <a:ext cx="338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dirty="0"/>
              <a:t>B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05266E00-AFA0-4E36-A8DF-D8C11C60D521}"/>
              </a:ext>
            </a:extLst>
          </p:cNvPr>
          <p:cNvGrpSpPr/>
          <p:nvPr/>
        </p:nvGrpSpPr>
        <p:grpSpPr>
          <a:xfrm>
            <a:off x="831680" y="1111444"/>
            <a:ext cx="2193589" cy="1198975"/>
            <a:chOff x="831680" y="1111444"/>
            <a:chExt cx="2193589" cy="1198975"/>
          </a:xfrm>
        </p:grpSpPr>
        <p:pic>
          <p:nvPicPr>
            <p:cNvPr id="8" name="Picture 7" descr="A picture containing text&#10;&#10;Description automatically generated">
              <a:extLst>
                <a:ext uri="{FF2B5EF4-FFF2-40B4-BE49-F238E27FC236}">
                  <a16:creationId xmlns:a16="http://schemas.microsoft.com/office/drawing/2014/main" id="{FAEBA184-E240-4C99-A50C-0D51DEEB0C87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443" t="17769" r="20487" b="60833"/>
            <a:stretch/>
          </p:blipFill>
          <p:spPr>
            <a:xfrm>
              <a:off x="1504030" y="1950419"/>
              <a:ext cx="14400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C063877-FF9C-49BF-89E8-0F410F14B204}"/>
                </a:ext>
              </a:extLst>
            </p:cNvPr>
            <p:cNvSpPr txBox="1"/>
            <p:nvPr/>
          </p:nvSpPr>
          <p:spPr>
            <a:xfrm>
              <a:off x="947091" y="1608094"/>
              <a:ext cx="48723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HK" sz="1400" dirty="0"/>
                <a:t>AKT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793CBE7A-E5E3-4350-AE1D-6F211ECA10FD}"/>
                </a:ext>
              </a:extLst>
            </p:cNvPr>
            <p:cNvSpPr txBox="1"/>
            <p:nvPr/>
          </p:nvSpPr>
          <p:spPr>
            <a:xfrm>
              <a:off x="831680" y="1970786"/>
              <a:ext cx="7643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HK" sz="1400" dirty="0"/>
                <a:t>Tubulin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8F0ED77-726F-47AE-AFCD-261D01173EFB}"/>
                </a:ext>
              </a:extLst>
            </p:cNvPr>
            <p:cNvSpPr txBox="1"/>
            <p:nvPr/>
          </p:nvSpPr>
          <p:spPr>
            <a:xfrm>
              <a:off x="1090693" y="1260149"/>
              <a:ext cx="727749" cy="2741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HK" sz="1400" dirty="0" err="1"/>
                <a:t>si</a:t>
              </a:r>
              <a:r>
                <a:rPr lang="en-HK" sz="1400" i="1" dirty="0" err="1"/>
                <a:t>A</a:t>
              </a:r>
              <a:r>
                <a:rPr lang="en-US" altLang="zh-CN" sz="1400" i="1" dirty="0" err="1"/>
                <a:t>kt</a:t>
              </a:r>
              <a:endParaRPr lang="en-HK" sz="1400" i="1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3691133-8C79-42A9-8822-D0B46F1FE7EC}"/>
                </a:ext>
              </a:extLst>
            </p:cNvPr>
            <p:cNvSpPr txBox="1"/>
            <p:nvPr/>
          </p:nvSpPr>
          <p:spPr>
            <a:xfrm>
              <a:off x="1616069" y="1111444"/>
              <a:ext cx="433727" cy="356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HK" sz="2000" dirty="0"/>
                <a:t>_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F0C7324-A42B-4C4A-BF70-4A4875629D95}"/>
                </a:ext>
              </a:extLst>
            </p:cNvPr>
            <p:cNvSpPr txBox="1"/>
            <p:nvPr/>
          </p:nvSpPr>
          <p:spPr>
            <a:xfrm>
              <a:off x="2007063" y="1265761"/>
              <a:ext cx="48882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HK" sz="1400" dirty="0"/>
                <a:t>+#1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C2633E1-CD24-4AFD-AFAB-42B3B1F959A5}"/>
                </a:ext>
              </a:extLst>
            </p:cNvPr>
            <p:cNvSpPr txBox="1"/>
            <p:nvPr/>
          </p:nvSpPr>
          <p:spPr>
            <a:xfrm>
              <a:off x="2496844" y="1268461"/>
              <a:ext cx="5284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HK" sz="1400" dirty="0"/>
                <a:t>+#2</a:t>
              </a:r>
            </a:p>
          </p:txBody>
        </p: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295126F3-92D2-44E6-A5B2-564BB65F1640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7376" r="16855" b="29909"/>
            <a:stretch/>
          </p:blipFill>
          <p:spPr>
            <a:xfrm>
              <a:off x="1502893" y="1543284"/>
              <a:ext cx="14400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17711352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65</TotalTime>
  <Words>98</Words>
  <Application>Microsoft Office PowerPoint</Application>
  <PresentationFormat>On-screen Show (4:3)</PresentationFormat>
  <Paragraphs>68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3</vt:i4>
      </vt:variant>
      <vt:variant>
        <vt:lpstr>Slide Titles</vt:lpstr>
      </vt:variant>
      <vt:variant>
        <vt:i4>7</vt:i4>
      </vt:variant>
    </vt:vector>
  </HeadingPairs>
  <TitlesOfParts>
    <vt:vector size="14" baseType="lpstr">
      <vt:lpstr>Arial</vt:lpstr>
      <vt:lpstr>Calibri</vt:lpstr>
      <vt:lpstr>Calibri Light</vt:lpstr>
      <vt:lpstr>Office Theme</vt:lpstr>
      <vt:lpstr>Prism 9</vt:lpstr>
      <vt:lpstr>Prism Project</vt:lpstr>
      <vt:lpstr>GraphPad Prism 9 Projec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icy</dc:creator>
  <cp:lastModifiedBy>潘 panicy</cp:lastModifiedBy>
  <cp:revision>170</cp:revision>
  <dcterms:created xsi:type="dcterms:W3CDTF">2019-05-16T13:39:54Z</dcterms:created>
  <dcterms:modified xsi:type="dcterms:W3CDTF">2021-09-01T01:10:15Z</dcterms:modified>
</cp:coreProperties>
</file>